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747487" y="983989"/>
              <a:ext cx="4583723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72991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07997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543003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747487" y="556478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747487" y="496205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747487" y="435931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747487" y="375657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747487" y="315384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747487" y="255110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747487" y="194836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747487" y="134563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05488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340494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475500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610506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05488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5900665" y="13456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700148" y="1345631"/>
              <a:ext cx="3200516" cy="0"/>
            </a:xfrm>
            <a:custGeom>
              <a:avLst/>
              <a:pathLst>
                <a:path w="3200516" h="0">
                  <a:moveTo>
                    <a:pt x="32005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700148" y="13456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5857243" y="1948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710084" y="1948367"/>
              <a:ext cx="3147159" cy="0"/>
            </a:xfrm>
            <a:custGeom>
              <a:avLst/>
              <a:pathLst>
                <a:path w="3147159" h="0">
                  <a:moveTo>
                    <a:pt x="31471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710084" y="1948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5932103" y="25511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613866" y="2551104"/>
              <a:ext cx="3318236" cy="0"/>
            </a:xfrm>
            <a:custGeom>
              <a:avLst/>
              <a:pathLst>
                <a:path w="3318236" h="0">
                  <a:moveTo>
                    <a:pt x="33182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613866" y="25511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6122859" y="37565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955838" y="3756577"/>
              <a:ext cx="4167021" cy="0"/>
            </a:xfrm>
            <a:custGeom>
              <a:avLst/>
              <a:pathLst>
                <a:path w="4167021" h="0">
                  <a:moveTo>
                    <a:pt x="41670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955838" y="37565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5800245" y="31538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659538" y="3153840"/>
              <a:ext cx="3140706" cy="0"/>
            </a:xfrm>
            <a:custGeom>
              <a:avLst/>
              <a:pathLst>
                <a:path w="3140706" h="0">
                  <a:moveTo>
                    <a:pt x="31407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659538" y="31538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5671787" y="43593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384868" y="4359314"/>
              <a:ext cx="3286918" cy="0"/>
            </a:xfrm>
            <a:custGeom>
              <a:avLst/>
              <a:pathLst>
                <a:path w="3286918" h="0">
                  <a:moveTo>
                    <a:pt x="32869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384868" y="43593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5725247" y="5564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684980" y="5564787"/>
              <a:ext cx="3040266" cy="0"/>
            </a:xfrm>
            <a:custGeom>
              <a:avLst/>
              <a:pathLst>
                <a:path w="3040266" h="0">
                  <a:moveTo>
                    <a:pt x="3040266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684980" y="5564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t43"/>
            <p:cNvSpPr/>
            <p:nvPr/>
          </p:nvSpPr>
          <p:spPr>
            <a:xfrm>
              <a:off x="4275580" y="13208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t44"/>
            <p:cNvSpPr/>
            <p:nvPr/>
          </p:nvSpPr>
          <p:spPr>
            <a:xfrm>
              <a:off x="4258838" y="19235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t45"/>
            <p:cNvSpPr/>
            <p:nvPr/>
          </p:nvSpPr>
          <p:spPr>
            <a:xfrm>
              <a:off x="4248159" y="25262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t46"/>
            <p:cNvSpPr/>
            <p:nvPr/>
          </p:nvSpPr>
          <p:spPr>
            <a:xfrm>
              <a:off x="4014523" y="37317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t47"/>
            <p:cNvSpPr/>
            <p:nvPr/>
          </p:nvSpPr>
          <p:spPr>
            <a:xfrm>
              <a:off x="4205065" y="31290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t48"/>
            <p:cNvSpPr/>
            <p:nvPr/>
          </p:nvSpPr>
          <p:spPr>
            <a:xfrm>
              <a:off x="4003502" y="43344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t49"/>
            <p:cNvSpPr/>
            <p:nvPr/>
          </p:nvSpPr>
          <p:spPr>
            <a:xfrm>
              <a:off x="4180288" y="5539961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747487" y="496205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tx51"/>
            <p:cNvSpPr/>
            <p:nvPr/>
          </p:nvSpPr>
          <p:spPr>
            <a:xfrm>
              <a:off x="1571946" y="5528423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1261193" y="432136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23288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1204688" y="371867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21085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1204688" y="311593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96125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1148183" y="251315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23218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1148183" y="191046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44979</a:t>
              </a:r>
            </a:p>
          </p:txBody>
        </p:sp>
        <p:sp>
          <p:nvSpPr>
            <p:cNvPr id="58" name="tx57"/>
            <p:cNvSpPr/>
            <p:nvPr/>
          </p:nvSpPr>
          <p:spPr>
            <a:xfrm>
              <a:off x="1148183" y="130767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53932</a:t>
              </a:r>
            </a:p>
          </p:txBody>
        </p:sp>
        <p:sp>
          <p:nvSpPr>
            <p:cNvPr id="59" name="pl58"/>
            <p:cNvSpPr/>
            <p:nvPr/>
          </p:nvSpPr>
          <p:spPr>
            <a:xfrm>
              <a:off x="1712693" y="55647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712693" y="49620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712693" y="43593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712693" y="37565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712693" y="31538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712693" y="25511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712693" y="19483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1712693" y="13456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05488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340494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475500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610506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0"/>
            <p:cNvSpPr/>
            <p:nvPr/>
          </p:nvSpPr>
          <p:spPr>
            <a:xfrm>
              <a:off x="1977206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72" name="tx71"/>
            <p:cNvSpPr/>
            <p:nvPr/>
          </p:nvSpPr>
          <p:spPr>
            <a:xfrm>
              <a:off x="3327266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73" name="tx72"/>
            <p:cNvSpPr/>
            <p:nvPr/>
          </p:nvSpPr>
          <p:spPr>
            <a:xfrm>
              <a:off x="4677326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74" name="tx73"/>
            <p:cNvSpPr/>
            <p:nvPr/>
          </p:nvSpPr>
          <p:spPr>
            <a:xfrm>
              <a:off x="6027386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6</a:t>
              </a:r>
            </a:p>
          </p:txBody>
        </p:sp>
        <p:sp>
          <p:nvSpPr>
            <p:cNvPr id="75" name="tx74"/>
            <p:cNvSpPr/>
            <p:nvPr/>
          </p:nvSpPr>
          <p:spPr>
            <a:xfrm>
              <a:off x="3130232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76" name="tx75"/>
            <p:cNvSpPr/>
            <p:nvPr/>
          </p:nvSpPr>
          <p:spPr>
            <a:xfrm>
              <a:off x="2129264" y="6214430"/>
              <a:ext cx="3820169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Overweight || id:ieu-a-93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3:38:59Z</dcterms:modified>
  <cp:category/>
</cp:coreProperties>
</file>